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C64D192-33E6-CB3E-FAC9-A76D0209E744}" name="IN LEE" initials="IL" userId="FNv6GgCGt97BOSRirN17DUPPwGAzu5qmY0d7rcoe62A=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33"/>
  </p:normalViewPr>
  <p:slideViewPr>
    <p:cSldViewPr snapToGrid="0" snapToObjects="1">
      <p:cViewPr varScale="1">
        <p:scale>
          <a:sx n="76" d="100"/>
          <a:sy n="76" d="100"/>
        </p:scale>
        <p:origin x="322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931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876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070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8083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3959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9165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77318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3730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898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571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794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20FCE-1FA8-5A41-ACF2-40CC3F04A898}" type="datetimeFigureOut">
              <a:rPr lang="en-US" smtClean="0"/>
              <a:t>3/1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892A9F-BB78-4647-B1B4-E8C2DFC24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659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449A59E3-242A-F34F-963F-FE3A567B6D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7072331"/>
              </p:ext>
            </p:extLst>
          </p:nvPr>
        </p:nvGraphicFramePr>
        <p:xfrm>
          <a:off x="292588" y="367144"/>
          <a:ext cx="6081986" cy="1381444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838322">
                  <a:extLst>
                    <a:ext uri="{9D8B030D-6E8A-4147-A177-3AD203B41FA5}">
                      <a16:colId xmlns:a16="http://schemas.microsoft.com/office/drawing/2014/main" val="3167409582"/>
                    </a:ext>
                  </a:extLst>
                </a:gridCol>
                <a:gridCol w="1608047">
                  <a:extLst>
                    <a:ext uri="{9D8B030D-6E8A-4147-A177-3AD203B41FA5}">
                      <a16:colId xmlns:a16="http://schemas.microsoft.com/office/drawing/2014/main" val="1784879395"/>
                    </a:ext>
                  </a:extLst>
                </a:gridCol>
                <a:gridCol w="2079558">
                  <a:extLst>
                    <a:ext uri="{9D8B030D-6E8A-4147-A177-3AD203B41FA5}">
                      <a16:colId xmlns:a16="http://schemas.microsoft.com/office/drawing/2014/main" val="3640039298"/>
                    </a:ext>
                  </a:extLst>
                </a:gridCol>
                <a:gridCol w="1556059">
                  <a:extLst>
                    <a:ext uri="{9D8B030D-6E8A-4147-A177-3AD203B41FA5}">
                      <a16:colId xmlns:a16="http://schemas.microsoft.com/office/drawing/2014/main" val="108872162"/>
                    </a:ext>
                  </a:extLst>
                </a:gridCol>
              </a:tblGrid>
              <a:tr h="17098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ample #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isease Statu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ytogenetic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utations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749329570"/>
                  </a:ext>
                </a:extLst>
              </a:tr>
              <a:tr h="20349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236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e Novo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6, XX, t(9;11)(p22;q23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LL-AF9+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3869459491"/>
                  </a:ext>
                </a:extLst>
              </a:tr>
              <a:tr h="17098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575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econdary Leukemia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6, XY, del(20)(q11.2q13.3)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ASXL1, NRAS, STSF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002506999"/>
                  </a:ext>
                </a:extLst>
              </a:tr>
              <a:tr h="22321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868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Relapsed Leukemia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Normal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KIT, TET2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Malgun Gothic" panose="020B0503020000020004" pitchFamily="34" charset="-127"/>
                        <a:cs typeface="Times New Roman" panose="02020603050405020304" pitchFamily="18" charset="0"/>
                      </a:endParaRP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2691582577"/>
                  </a:ext>
                </a:extLst>
              </a:tr>
              <a:tr h="22321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5882</a:t>
                      </a: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De Novo</a:t>
                      </a: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FLT3, RUNX1, STAG2, ASXL1, TET2</a:t>
                      </a: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533506302"/>
                  </a:ext>
                </a:extLst>
              </a:tr>
              <a:tr h="22321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6793</a:t>
                      </a: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De Novo</a:t>
                      </a: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68323" marR="68323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Malgun Gothic" panose="020B0503020000020004" pitchFamily="34" charset="-127"/>
                          <a:cs typeface="Times New Roman" panose="02020603050405020304" pitchFamily="18" charset="0"/>
                        </a:rPr>
                        <a:t>FLT3, DNMT3A</a:t>
                      </a:r>
                    </a:p>
                  </a:txBody>
                  <a:tcPr marL="68323" marR="68323" marT="0" marB="0"/>
                </a:tc>
                <a:extLst>
                  <a:ext uri="{0D108BD9-81ED-4DB2-BD59-A6C34878D82A}">
                    <a16:rowId xmlns:a16="http://schemas.microsoft.com/office/drawing/2014/main" val="1655803012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AEAF44D4-DA31-2AAA-65BB-99801C1F4F49}"/>
              </a:ext>
            </a:extLst>
          </p:cNvPr>
          <p:cNvSpPr txBox="1"/>
          <p:nvPr/>
        </p:nvSpPr>
        <p:spPr>
          <a:xfrm>
            <a:off x="292588" y="1868594"/>
            <a:ext cx="6081987" cy="52322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 dirty="0"/>
              <a:t>Supplementary Table S2. </a:t>
            </a:r>
            <a:r>
              <a:rPr lang="en-US" sz="1400" dirty="0"/>
              <a:t>Profile of primary human AML samples used in colony formation assay.</a:t>
            </a:r>
            <a:endParaRPr lang="en-US" sz="1400" b="1" dirty="0">
              <a:ea typeface="+mn-lt"/>
              <a:cs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2724793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10</TotalTime>
  <Words>88</Words>
  <Application>Microsoft Macintosh PowerPoint</Application>
  <PresentationFormat>A4 Paper (210x297 mm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In</dc:creator>
  <cp:lastModifiedBy>Lee, In</cp:lastModifiedBy>
  <cp:revision>288</cp:revision>
  <dcterms:created xsi:type="dcterms:W3CDTF">2022-09-08T02:26:07Z</dcterms:created>
  <dcterms:modified xsi:type="dcterms:W3CDTF">2023-03-17T14:49:36Z</dcterms:modified>
</cp:coreProperties>
</file>